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12192000" cy="6858000"/>
  <p:notesSz cx="6858000" cy="9144000"/>
  <p:defaultTextStyle>
    <a:defPPr>
      <a:defRPr lang="en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93" autoAdjust="0"/>
    <p:restoredTop sz="94660"/>
  </p:normalViewPr>
  <p:slideViewPr>
    <p:cSldViewPr snapToGrid="0" showGuides="1">
      <p:cViewPr varScale="1">
        <p:scale>
          <a:sx n="82" d="100"/>
          <a:sy n="82" d="100"/>
        </p:scale>
        <p:origin x="126" y="34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1AC75DA-876C-9814-7DE4-179093D6848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C5BA292-FE38-AEFF-D734-A5DE75EE379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341F4E-8D10-0C49-A11F-F8BB6ACDF4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260E3A5-A250-A72D-0655-8681028415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3E4995-1A25-5613-3CB7-F8F1FBCA1B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1165811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153C7E-249C-C608-C640-68C35A1FFF4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16A180C-B2AB-BFA0-1DD2-C57FFCE6D56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D53947-AF88-AD42-11FB-5027FC7703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91670A-E8BF-FBE7-B76E-6AAB0061A1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D2F002-18E4-F467-0691-217B8C1193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0329213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09086AB-956A-6EF1-5DBB-DC43E5DBA19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44E7BCA-4ADA-1998-0E0E-F5021CC4F32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4248976-69F8-ED46-0B5C-F590C0710C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A7D4A30-63B2-A4DD-4502-3B1DDB582C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78DD4B-AD6E-9022-46A0-57067D699D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9898131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156398-2E91-DCCA-7A89-1D84D13785A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8DCC001-5649-AB4E-6494-ACD12990FE9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78D962-9ED6-6567-7417-E76244A7FC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6E149EF-7CD2-8C65-7EEB-76B4D83A3D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18CDEF-2DDF-E3D9-3B5E-61A639C609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5242059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F82F80-993F-D2FB-0DBA-485FD4D8FF8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F56A2D8-14C2-C746-3B1D-933005CAF8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1437D5-A396-81BA-47E0-EEEFE0AFB3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6855B5-4FF2-A87D-2D42-1C91F9C53A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93100FB-51DD-A3CD-2E67-524D388911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0730980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228DD7-A945-C1E3-815F-26FD23C195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A54B4C6-90E7-8E99-6217-194852FC0D0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D02E0C6-144D-ECB8-72A3-2748FD7AE3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943D97D-D2D0-176E-562F-6CFEEC3FE4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62ABEDC-26DF-E91A-B279-A0E42BB3AE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E0BB212-CE38-9BFC-1BEE-003AE576C8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97844251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006D5F-0CE7-3109-267A-DDE0F6EEDD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ACE52BF-CBF4-9A79-43C2-00FD8F6046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8ED3AA0-6116-EEB4-2ADD-46D16E7A9A7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DA17345-989F-CAFF-E538-29AECBE2AEC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C4AAA2BB-06A9-515E-E6D7-40B6761B8A5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24B79C1-3F57-F46E-C41E-754344EB6CF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AD21308-54ED-803A-630E-076B9A4256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E54443E-6521-6B03-E4A5-0DF282F47E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7990429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5FE944-4B0A-DBE3-1026-336F0EA6D68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1D9B25A-F645-7109-DFD8-8A3E209DC0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B3639BA-8140-AFE8-E84A-5AE1DB01F1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05D4F7E-18F3-E380-29A4-A761E131AB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3387314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DECAAC5-A8F4-D635-2AF1-B6AF071C8F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20E0357-85EC-A8C4-13EE-E9DF67E411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A465C70-5E4A-37F7-0442-2A0CBD8EE1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6566154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F185375-7F61-062D-AB1C-DF9C5654B2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B03E477-406E-C5F5-4B78-E5E53C0548E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87B9FAC-3F01-D384-6DA5-DF78FA169FD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965789E-63D7-54B7-0C33-A70C241BF4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287737B-EC50-0FEF-DA55-B81A8B1A34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0094EC0-CEAE-21D8-8AE5-5B165533CF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3374772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DD1A9F-C6F0-792B-050C-29C4DFDFD9B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FE15C31-1847-8321-3FB3-09E6B813D7B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D3766E6-64D7-4E38-1599-707BD73E385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16E8DF5-E161-B255-0C7B-9FABBF9CCA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FA97C65-43FA-49B8-125B-AC7F7FA259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517EA60-AE12-BB00-E775-17EE0201D8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2422843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981378DE-852B-CFB7-9A7A-0835366275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D1828B3-FE3D-3926-B625-63B9F59B69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B7AED3-ED14-68E6-52DD-3E815FF5F7B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FFD6FFB-4BC8-4BA5-AFF5-6DF09D64A428}" type="datetimeFigureOut">
              <a:rPr lang="en-DE" smtClean="0"/>
              <a:t>14/08/2024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141B404-05E3-EF5C-F3ED-A45358ABC61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1E35E14-3BAD-3053-0D55-C41CCC65FB1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F501E1D-F92B-4D89-8DFF-0004BC8D156A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0616706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1F019CFD-8D96-4025-8E05-953EECB7C57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361" t="37900" r="3307" b="10055"/>
          <a:stretch/>
        </p:blipFill>
        <p:spPr bwMode="auto">
          <a:xfrm>
            <a:off x="4071730" y="2985811"/>
            <a:ext cx="4048539" cy="3233532"/>
          </a:xfrm>
          <a:prstGeom prst="rect">
            <a:avLst/>
          </a:prstGeom>
          <a:ln>
            <a:noFill/>
          </a:ln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D701BD83-FC74-470A-BBB6-7085A6992278}"/>
              </a:ext>
            </a:extLst>
          </p:cNvPr>
          <p:cNvSpPr/>
          <p:nvPr/>
        </p:nvSpPr>
        <p:spPr>
          <a:xfrm>
            <a:off x="4593534" y="4302608"/>
            <a:ext cx="2808000" cy="31319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E9B6E06-AA3A-41CE-80E9-FCA43109A205}"/>
              </a:ext>
            </a:extLst>
          </p:cNvPr>
          <p:cNvSpPr txBox="1"/>
          <p:nvPr/>
        </p:nvSpPr>
        <p:spPr>
          <a:xfrm>
            <a:off x="7769664" y="4294800"/>
            <a:ext cx="7521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err="1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MLKL</a:t>
            </a:r>
            <a:endParaRPr lang="en-DE" sz="1400" dirty="0">
              <a:solidFill>
                <a:srgbClr val="FF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4D657A6-7678-ABDC-D22C-73F72D6D42A4}"/>
              </a:ext>
            </a:extLst>
          </p:cNvPr>
          <p:cNvSpPr txBox="1"/>
          <p:nvPr/>
        </p:nvSpPr>
        <p:spPr>
          <a:xfrm rot="16200000">
            <a:off x="4637446" y="2774076"/>
            <a:ext cx="3898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V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4BEF9FB9-66B2-82F7-DEE1-BAC642AAC8D7}"/>
              </a:ext>
            </a:extLst>
          </p:cNvPr>
          <p:cNvSpPr txBox="1"/>
          <p:nvPr/>
        </p:nvSpPr>
        <p:spPr>
          <a:xfrm rot="16200000">
            <a:off x="5275103" y="1564338"/>
            <a:ext cx="2809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 + ZBP1-S-Sc (moderate)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33C4440-E62B-8BC2-0211-149B080ACD88}"/>
              </a:ext>
            </a:extLst>
          </p:cNvPr>
          <p:cNvSpPr txBox="1"/>
          <p:nvPr/>
        </p:nvSpPr>
        <p:spPr>
          <a:xfrm rot="16200000">
            <a:off x="4815563" y="2485455"/>
            <a:ext cx="9877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824EE25-A27E-6DDD-C823-2FBCBA1BB583}"/>
              </a:ext>
            </a:extLst>
          </p:cNvPr>
          <p:cNvSpPr txBox="1"/>
          <p:nvPr/>
        </p:nvSpPr>
        <p:spPr>
          <a:xfrm rot="16200000">
            <a:off x="5574852" y="2365081"/>
            <a:ext cx="13003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mZ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L-NG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4B00F61-FAC8-BA3C-D69C-DCB1C4C861FB}"/>
              </a:ext>
            </a:extLst>
          </p:cNvPr>
          <p:cNvSpPr txBox="1"/>
          <p:nvPr/>
        </p:nvSpPr>
        <p:spPr>
          <a:xfrm rot="16200000">
            <a:off x="5293241" y="2538205"/>
            <a:ext cx="95410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S-Sc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917AE9C-66DA-FDC0-59E3-CAF5852A478C}"/>
              </a:ext>
            </a:extLst>
          </p:cNvPr>
          <p:cNvSpPr txBox="1"/>
          <p:nvPr/>
        </p:nvSpPr>
        <p:spPr>
          <a:xfrm rot="16200000">
            <a:off x="5735949" y="1610595"/>
            <a:ext cx="28093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ZBP1-L-NG + ZBP1-S-Sc (high)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2BE7A5A2-0F6E-30E6-5C2A-E5824F72F81F}"/>
              </a:ext>
            </a:extLst>
          </p:cNvPr>
          <p:cNvCxnSpPr>
            <a:cxnSpLocks/>
          </p:cNvCxnSpPr>
          <p:nvPr/>
        </p:nvCxnSpPr>
        <p:spPr>
          <a:xfrm>
            <a:off x="4658139" y="3118089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100224E7-F8DF-966E-9FE1-04D3243F51A1}"/>
              </a:ext>
            </a:extLst>
          </p:cNvPr>
          <p:cNvCxnSpPr>
            <a:cxnSpLocks/>
          </p:cNvCxnSpPr>
          <p:nvPr/>
        </p:nvCxnSpPr>
        <p:spPr>
          <a:xfrm>
            <a:off x="5121965" y="3118089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5" name="Straight Connector 14">
            <a:extLst>
              <a:ext uri="{FF2B5EF4-FFF2-40B4-BE49-F238E27FC236}">
                <a16:creationId xmlns:a16="http://schemas.microsoft.com/office/drawing/2014/main" id="{2E290143-4EE5-2EB6-03A9-FFFFEFD76497}"/>
              </a:ext>
            </a:extLst>
          </p:cNvPr>
          <p:cNvCxnSpPr>
            <a:cxnSpLocks/>
          </p:cNvCxnSpPr>
          <p:nvPr/>
        </p:nvCxnSpPr>
        <p:spPr>
          <a:xfrm>
            <a:off x="5582810" y="3117840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6" name="Straight Connector 15">
            <a:extLst>
              <a:ext uri="{FF2B5EF4-FFF2-40B4-BE49-F238E27FC236}">
                <a16:creationId xmlns:a16="http://schemas.microsoft.com/office/drawing/2014/main" id="{FBAE9A09-10EE-5F3E-6FF3-D5B79609495F}"/>
              </a:ext>
            </a:extLst>
          </p:cNvPr>
          <p:cNvCxnSpPr>
            <a:cxnSpLocks/>
          </p:cNvCxnSpPr>
          <p:nvPr/>
        </p:nvCxnSpPr>
        <p:spPr>
          <a:xfrm>
            <a:off x="6037290" y="3117840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DD9FE5CD-904E-3B06-F95E-B6714F60C4D8}"/>
              </a:ext>
            </a:extLst>
          </p:cNvPr>
          <p:cNvCxnSpPr>
            <a:cxnSpLocks/>
          </p:cNvCxnSpPr>
          <p:nvPr/>
        </p:nvCxnSpPr>
        <p:spPr>
          <a:xfrm>
            <a:off x="6486939" y="3120255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518AF649-6AA5-6C42-34D5-EB5CD352645D}"/>
              </a:ext>
            </a:extLst>
          </p:cNvPr>
          <p:cNvCxnSpPr>
            <a:cxnSpLocks/>
          </p:cNvCxnSpPr>
          <p:nvPr/>
        </p:nvCxnSpPr>
        <p:spPr>
          <a:xfrm>
            <a:off x="6944139" y="3117840"/>
            <a:ext cx="374968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01604F55-106C-16BB-D1A0-3822123DBEA6}"/>
              </a:ext>
            </a:extLst>
          </p:cNvPr>
          <p:cNvSpPr txBox="1"/>
          <p:nvPr/>
        </p:nvSpPr>
        <p:spPr>
          <a:xfrm>
            <a:off x="4067899" y="3153758"/>
            <a:ext cx="4571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Dox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6D38C52-A193-114F-9097-033B2A71071B}"/>
              </a:ext>
            </a:extLst>
          </p:cNvPr>
          <p:cNvSpPr txBox="1"/>
          <p:nvPr/>
        </p:nvSpPr>
        <p:spPr>
          <a:xfrm>
            <a:off x="3687094" y="3433225"/>
            <a:ext cx="9092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Emricasan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6309240-E422-9FBD-9A46-4D482B9669FC}"/>
              </a:ext>
            </a:extLst>
          </p:cNvPr>
          <p:cNvSpPr txBox="1"/>
          <p:nvPr/>
        </p:nvSpPr>
        <p:spPr>
          <a:xfrm>
            <a:off x="4593534" y="3137032"/>
            <a:ext cx="28200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Symbol" panose="05050102010706020507" pitchFamily="18" charset="2"/>
                <a:cs typeface="Arial" panose="020B0604020202020204" pitchFamily="34" charset="0"/>
              </a:rPr>
              <a:t>+    +    +    +    +    +    +   +    +   +    +    +</a:t>
            </a:r>
            <a:endParaRPr lang="en-DE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CA51055-D077-1B69-859E-E488EE181C70}"/>
              </a:ext>
            </a:extLst>
          </p:cNvPr>
          <p:cNvSpPr txBox="1"/>
          <p:nvPr/>
        </p:nvSpPr>
        <p:spPr>
          <a:xfrm>
            <a:off x="4593534" y="3386418"/>
            <a:ext cx="282000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Symbol" panose="05050102010706020507" pitchFamily="18" charset="2"/>
                <a:cs typeface="Arial" panose="020B0604020202020204" pitchFamily="34" charset="0"/>
              </a:rPr>
              <a:t>-    +    -    +    -    +    -   +    -   +    -    +</a:t>
            </a:r>
            <a:endParaRPr lang="en-DE" sz="1200" dirty="0">
              <a:latin typeface="Symbol" panose="05050102010706020507" pitchFamily="18" charset="2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647ACA5-BE1A-948C-ED1A-B29BBBC211F7}"/>
              </a:ext>
            </a:extLst>
          </p:cNvPr>
          <p:cNvSpPr txBox="1"/>
          <p:nvPr/>
        </p:nvSpPr>
        <p:spPr>
          <a:xfrm>
            <a:off x="1014222" y="1025027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Blot 1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CBF34FA7-192D-401A-9787-46B59A9B98DD}"/>
              </a:ext>
            </a:extLst>
          </p:cNvPr>
          <p:cNvCxnSpPr>
            <a:cxnSpLocks/>
          </p:cNvCxnSpPr>
          <p:nvPr/>
        </p:nvCxnSpPr>
        <p:spPr>
          <a:xfrm>
            <a:off x="4273075" y="4766867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" name="TextBox 36">
            <a:extLst>
              <a:ext uri="{FF2B5EF4-FFF2-40B4-BE49-F238E27FC236}">
                <a16:creationId xmlns:a16="http://schemas.microsoft.com/office/drawing/2014/main" id="{015C0B8D-58E3-4DE6-BF19-454CE4EFE6F3}"/>
              </a:ext>
            </a:extLst>
          </p:cNvPr>
          <p:cNvSpPr txBox="1"/>
          <p:nvPr/>
        </p:nvSpPr>
        <p:spPr>
          <a:xfrm>
            <a:off x="3944689" y="4624797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648850D4-1A6F-4202-BA77-74E331369C68}"/>
              </a:ext>
            </a:extLst>
          </p:cNvPr>
          <p:cNvCxnSpPr>
            <a:cxnSpLocks/>
          </p:cNvCxnSpPr>
          <p:nvPr/>
        </p:nvCxnSpPr>
        <p:spPr>
          <a:xfrm>
            <a:off x="4273075" y="4989900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7" name="TextBox 38">
            <a:extLst>
              <a:ext uri="{FF2B5EF4-FFF2-40B4-BE49-F238E27FC236}">
                <a16:creationId xmlns:a16="http://schemas.microsoft.com/office/drawing/2014/main" id="{17857408-0151-4A47-A829-79D29D6676A7}"/>
              </a:ext>
            </a:extLst>
          </p:cNvPr>
          <p:cNvSpPr txBox="1"/>
          <p:nvPr/>
        </p:nvSpPr>
        <p:spPr>
          <a:xfrm>
            <a:off x="3944689" y="4847830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F10E8EB3-7ABC-44AF-817B-43C42A7602A7}"/>
              </a:ext>
            </a:extLst>
          </p:cNvPr>
          <p:cNvCxnSpPr>
            <a:cxnSpLocks/>
          </p:cNvCxnSpPr>
          <p:nvPr/>
        </p:nvCxnSpPr>
        <p:spPr>
          <a:xfrm>
            <a:off x="4279211" y="4408943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TextBox 40">
            <a:extLst>
              <a:ext uri="{FF2B5EF4-FFF2-40B4-BE49-F238E27FC236}">
                <a16:creationId xmlns:a16="http://schemas.microsoft.com/office/drawing/2014/main" id="{4FBBD120-0B82-462B-A1A0-ADED2852B0B5}"/>
              </a:ext>
            </a:extLst>
          </p:cNvPr>
          <p:cNvSpPr txBox="1"/>
          <p:nvPr/>
        </p:nvSpPr>
        <p:spPr>
          <a:xfrm>
            <a:off x="3950825" y="4266873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58655F5B-6626-43D2-B335-371BEE968A8D}"/>
              </a:ext>
            </a:extLst>
          </p:cNvPr>
          <p:cNvCxnSpPr>
            <a:cxnSpLocks/>
          </p:cNvCxnSpPr>
          <p:nvPr/>
        </p:nvCxnSpPr>
        <p:spPr>
          <a:xfrm>
            <a:off x="4273075" y="4204142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1" name="TextBox 42">
            <a:extLst>
              <a:ext uri="{FF2B5EF4-FFF2-40B4-BE49-F238E27FC236}">
                <a16:creationId xmlns:a16="http://schemas.microsoft.com/office/drawing/2014/main" id="{914F6FFB-42E7-41F6-B136-B2A94CF3501B}"/>
              </a:ext>
            </a:extLst>
          </p:cNvPr>
          <p:cNvSpPr txBox="1"/>
          <p:nvPr/>
        </p:nvSpPr>
        <p:spPr>
          <a:xfrm>
            <a:off x="3944689" y="4055299"/>
            <a:ext cx="3545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4DC44C71-8904-48A6-BFEC-21720B43FB9B}"/>
              </a:ext>
            </a:extLst>
          </p:cNvPr>
          <p:cNvCxnSpPr>
            <a:cxnSpLocks/>
          </p:cNvCxnSpPr>
          <p:nvPr/>
        </p:nvCxnSpPr>
        <p:spPr>
          <a:xfrm>
            <a:off x="4273075" y="4089904"/>
            <a:ext cx="25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3" name="TextBox 42">
            <a:extLst>
              <a:ext uri="{FF2B5EF4-FFF2-40B4-BE49-F238E27FC236}">
                <a16:creationId xmlns:a16="http://schemas.microsoft.com/office/drawing/2014/main" id="{2CA58868-248F-4A84-8F93-6A902DF23820}"/>
              </a:ext>
            </a:extLst>
          </p:cNvPr>
          <p:cNvSpPr txBox="1"/>
          <p:nvPr/>
        </p:nvSpPr>
        <p:spPr>
          <a:xfrm>
            <a:off x="3859729" y="392239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D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  <a:endParaRPr lang="en-DE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686949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2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asmin Carvalho Schäfer</dc:creator>
  <cp:lastModifiedBy>mnagata</cp:lastModifiedBy>
  <cp:revision>2</cp:revision>
  <dcterms:created xsi:type="dcterms:W3CDTF">2024-08-13T14:15:55Z</dcterms:created>
  <dcterms:modified xsi:type="dcterms:W3CDTF">2024-08-14T21:51:47Z</dcterms:modified>
</cp:coreProperties>
</file>